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embeddedFontLst>
    <p:embeddedFont>
      <p:font typeface="Play" panose="020B0604020202020204" charset="0"/>
      <p:regular r:id="rId5"/>
      <p:bold r:id="rId6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hxWkB5l8yi78FgNrBmQa4mi7ltb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22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viewProps" Target="viewProps.xml"/><Relationship Id="rId5" Type="http://schemas.openxmlformats.org/officeDocument/2006/relationships/font" Target="fonts/font1.fntdata"/><Relationship Id="rId10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5" name="Google Shape;95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5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5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7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7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500"/>
              <a:buNone/>
              <a:defRPr sz="15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350"/>
              <a:buNone/>
              <a:defRPr sz="135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8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9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9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9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9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9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0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Play"/>
              <a:buNone/>
              <a:defRPr sz="33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14882" y="146279"/>
            <a:ext cx="2789540" cy="38774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5" name="Google Shape;85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559695" y="146281"/>
            <a:ext cx="2789539" cy="3877460"/>
          </a:xfrm>
          <a:prstGeom prst="rect">
            <a:avLst/>
          </a:prstGeom>
          <a:noFill/>
          <a:ln>
            <a:noFill/>
          </a:ln>
        </p:spPr>
      </p:pic>
      <p:pic>
        <p:nvPicPr>
          <p:cNvPr id="86" name="Google Shape;86;p1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559694" y="4402939"/>
            <a:ext cx="2789540" cy="38774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14882" y="4402939"/>
            <a:ext cx="2789540" cy="3877461"/>
          </a:xfrm>
          <a:prstGeom prst="rect">
            <a:avLst/>
          </a:prstGeom>
          <a:noFill/>
          <a:ln>
            <a:noFill/>
          </a:ln>
        </p:spPr>
      </p:pic>
      <p:sp>
        <p:nvSpPr>
          <p:cNvPr id="88" name="Google Shape;88;p1"/>
          <p:cNvSpPr txBox="1"/>
          <p:nvPr/>
        </p:nvSpPr>
        <p:spPr>
          <a:xfrm>
            <a:off x="187639" y="146279"/>
            <a:ext cx="4283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)</a:t>
            </a:r>
            <a:endParaRPr/>
          </a:p>
        </p:txBody>
      </p:sp>
      <p:sp>
        <p:nvSpPr>
          <p:cNvPr id="89" name="Google Shape;89;p1"/>
          <p:cNvSpPr txBox="1"/>
          <p:nvPr/>
        </p:nvSpPr>
        <p:spPr>
          <a:xfrm>
            <a:off x="3617904" y="146279"/>
            <a:ext cx="4154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)</a:t>
            </a:r>
            <a:endParaRPr/>
          </a:p>
        </p:txBody>
      </p:sp>
      <p:sp>
        <p:nvSpPr>
          <p:cNvPr id="90" name="Google Shape;90;p1"/>
          <p:cNvSpPr txBox="1"/>
          <p:nvPr/>
        </p:nvSpPr>
        <p:spPr>
          <a:xfrm>
            <a:off x="182946" y="4339170"/>
            <a:ext cx="41549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)</a:t>
            </a:r>
            <a:endParaRPr/>
          </a:p>
        </p:txBody>
      </p:sp>
      <p:sp>
        <p:nvSpPr>
          <p:cNvPr id="91" name="Google Shape;91;p1"/>
          <p:cNvSpPr txBox="1"/>
          <p:nvPr/>
        </p:nvSpPr>
        <p:spPr>
          <a:xfrm>
            <a:off x="3716468" y="4339169"/>
            <a:ext cx="4283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D)</a:t>
            </a:r>
            <a:endParaRPr/>
          </a:p>
        </p:txBody>
      </p:sp>
      <p:sp>
        <p:nvSpPr>
          <p:cNvPr id="92" name="Google Shape;92;p1"/>
          <p:cNvSpPr txBox="1"/>
          <p:nvPr/>
        </p:nvSpPr>
        <p:spPr>
          <a:xfrm>
            <a:off x="125774" y="8280400"/>
            <a:ext cx="6606600" cy="138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3 (part 1). </a:t>
            </a:r>
            <a:r>
              <a:rPr lang="en-US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Venn diagram comparisons of RNA-Seq derived DEGs: MAGE meta-analysis versus database-sourced data. A) DEGs from seedling-shoot RNA-Seq studies: Comparison between MAGE-processed study data and the final meta-analysis results; B) DEGs from seedling-shoot RNA-Seq studies: Comparison between data as extracted from supplementary files and the MAGE meta-analysis results; C) DEGs from root RNA-Seq studies: Comparison between MAGE-processed study data and the final meta-analysis results; D) DEGs from root RNA-Seq studies: Comparison between data as extracted from supplementary files and the MAGE meta-analysis results.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Google Shape;97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96289" y="239712"/>
            <a:ext cx="2905849" cy="4039130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765826" y="239712"/>
            <a:ext cx="2905849" cy="4039130"/>
          </a:xfrm>
          <a:prstGeom prst="rect">
            <a:avLst/>
          </a:prstGeom>
          <a:noFill/>
          <a:ln>
            <a:noFill/>
          </a:ln>
        </p:spPr>
      </p:pic>
      <p:pic>
        <p:nvPicPr>
          <p:cNvPr id="99" name="Google Shape;99;p2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96289" y="4330169"/>
            <a:ext cx="2905848" cy="40391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00" name="Google Shape;100;p2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765827" y="4330169"/>
            <a:ext cx="2905848" cy="4039129"/>
          </a:xfrm>
          <a:prstGeom prst="rect">
            <a:avLst/>
          </a:prstGeom>
          <a:noFill/>
          <a:ln>
            <a:noFill/>
          </a:ln>
        </p:spPr>
      </p:pic>
      <p:sp>
        <p:nvSpPr>
          <p:cNvPr id="101" name="Google Shape;101;p2"/>
          <p:cNvSpPr txBox="1"/>
          <p:nvPr/>
        </p:nvSpPr>
        <p:spPr>
          <a:xfrm>
            <a:off x="139349" y="8373365"/>
            <a:ext cx="6606452" cy="13849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3 (part 2). </a:t>
            </a:r>
            <a:r>
              <a:rPr lang="en-US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Venn diagram comparisons of microarray-derived DEGs: MAGE meta-analysis versus database-sourced data. E) DEGs from seedling-shoot microarray studies: Comparison between MAGE-processed study data and the final meta-analysis results; F) DEGs from seedling-shoot microarray studies: Comparison between data as extracted from supplementary files and the MAGE meta-analysis results; G) DEGs from root microarray studies: Comparison between MAGE-processed study data and the final meta-analysis results; H) DEGs from root microarray studies: Comparison between data as extracted from supplementary files and the MAGE meta-analysis results.</a:t>
            </a:r>
            <a:endParaRPr/>
          </a:p>
        </p:txBody>
      </p:sp>
      <p:sp>
        <p:nvSpPr>
          <p:cNvPr id="102" name="Google Shape;102;p2"/>
          <p:cNvSpPr txBox="1"/>
          <p:nvPr/>
        </p:nvSpPr>
        <p:spPr>
          <a:xfrm>
            <a:off x="313503" y="239712"/>
            <a:ext cx="40267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)</a:t>
            </a:r>
            <a:endParaRPr/>
          </a:p>
        </p:txBody>
      </p:sp>
      <p:sp>
        <p:nvSpPr>
          <p:cNvPr id="103" name="Google Shape;103;p2"/>
          <p:cNvSpPr txBox="1"/>
          <p:nvPr/>
        </p:nvSpPr>
        <p:spPr>
          <a:xfrm>
            <a:off x="4019000" y="239712"/>
            <a:ext cx="402674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F)</a:t>
            </a:r>
            <a:endParaRPr/>
          </a:p>
        </p:txBody>
      </p:sp>
      <p:sp>
        <p:nvSpPr>
          <p:cNvPr id="104" name="Google Shape;104;p2"/>
          <p:cNvSpPr txBox="1"/>
          <p:nvPr/>
        </p:nvSpPr>
        <p:spPr>
          <a:xfrm>
            <a:off x="313503" y="4239220"/>
            <a:ext cx="4283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G)</a:t>
            </a:r>
            <a:endParaRPr/>
          </a:p>
        </p:txBody>
      </p:sp>
      <p:sp>
        <p:nvSpPr>
          <p:cNvPr id="105" name="Google Shape;105;p2"/>
          <p:cNvSpPr txBox="1"/>
          <p:nvPr/>
        </p:nvSpPr>
        <p:spPr>
          <a:xfrm>
            <a:off x="4006176" y="4239220"/>
            <a:ext cx="4283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H)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1</Words>
  <Application>Microsoft Office PowerPoint</Application>
  <PresentationFormat>A4 Paper (210x297 mm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Play</vt:lpstr>
      <vt:lpstr>Times New Roman</vt:lpstr>
      <vt:lpstr>Aria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KAMPA MARIA</dc:creator>
  <cp:lastModifiedBy>KAMPA MARIA</cp:lastModifiedBy>
  <cp:revision>1</cp:revision>
  <dcterms:created xsi:type="dcterms:W3CDTF">2026-03-16T08:56:33Z</dcterms:created>
  <dcterms:modified xsi:type="dcterms:W3CDTF">2026-03-16T18:34:57Z</dcterms:modified>
</cp:coreProperties>
</file>